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1028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8000" cy="51264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t">
            <a:noAutofit/>
          </a:bodyPr>
          <a:p>
            <a:pPr indent="0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r>
              <a:rPr b="0" lang="en-GB" sz="13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4440" y="0"/>
            <a:ext cx="3078000" cy="51264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t">
            <a:noAutofit/>
          </a:bodyPr>
          <a:lstStyle>
            <a:lvl1pPr indent="0" algn="r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  <a:defRPr b="0" lang="en-GB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r>
              <a:rPr b="0" lang="en-GB" sz="13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2480" y="768240"/>
            <a:ext cx="2876760" cy="38354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11360" y="4861080"/>
            <a:ext cx="5681520" cy="460512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8000" cy="51120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b">
            <a:noAutofit/>
          </a:bodyPr>
          <a:lstStyle>
            <a:lvl1pPr indent="0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  <a:defRPr b="0" lang="en-GB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r>
              <a:rPr b="0" lang="en-GB" sz="13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4440" y="9721800"/>
            <a:ext cx="3078000" cy="51120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b">
            <a:noAutofit/>
          </a:bodyPr>
          <a:lstStyle>
            <a:lvl1pPr indent="0" algn="r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  <a:defRPr b="0" lang="en-GB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fld id="{E953F7F6-BEFB-4D4E-AA02-DEDCC16432C4}" type="slidenum">
              <a:rPr b="0" lang="en-GB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6" name="PlaceHolder 1"/>
          <p:cNvSpPr>
            <a:spLocks noGrp="1"/>
          </p:cNvSpPr>
          <p:nvPr>
            <p:ph type="sldImg"/>
          </p:nvPr>
        </p:nvSpPr>
        <p:spPr>
          <a:xfrm>
            <a:off x="2112840" y="768240"/>
            <a:ext cx="2876760" cy="3835440"/>
          </a:xfrm>
          <a:prstGeom prst="rect">
            <a:avLst/>
          </a:prstGeom>
          <a:ln w="0">
            <a:noFill/>
          </a:ln>
        </p:spPr>
      </p:sp>
      <p:sp>
        <p:nvSpPr>
          <p:cNvPr id="397" name="PlaceHolder 2"/>
          <p:cNvSpPr>
            <a:spLocks noGrp="1"/>
          </p:cNvSpPr>
          <p:nvPr>
            <p:ph type="body"/>
          </p:nvPr>
        </p:nvSpPr>
        <p:spPr>
          <a:xfrm>
            <a:off x="711360" y="4861080"/>
            <a:ext cx="5681520" cy="460512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520" bIns="475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) Follow-up by flow cytometry assessments of the absolute Numbers of CD19+ B-lymphocytes, CD4+ T-cells and CD8+T-cells in the peripheral blood of the indicated macaque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) Sequential follow-up of serum antiadenoviral neutralizing antibodies in the color-coded animals as described in fig.1. C) Sequential follow-up of proliferative response of PBMC. D) Anti-PBGD antibodies are not detectable in any serum from macaques injected with AAV2/5-aat-pbgd (a) Purified recombinant PBGD protein were resolved by electrophoresis on a 12% polyacrylamide gel and blotted onto PVDF membranes (Amersham HybondTM-P, Buckimghamshire.UK). After blocking, the membranes were incubated with rabbit anti-PBGD serum (dilution 1:300) as positive control, or sera from macaques 003, 004 or 005 (diluted 1:3 in PBS). Secondary antibodies used were anti- rabbit (1:5000, GAR, Biorad) or anti- monkey (1:400, GAMONKEY, Pierce- Rockford. IL, USA). The signals were then visualized using a streptavidina-HRP-Conjugate (dil 1:25000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1F264-D1C5-4DD8-B6F8-F9C7C9874F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460D6-98E2-4C8A-91D0-1451023451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4A4AB-CFC8-4C36-9163-881FD3C63A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48B61-0B44-40A1-A3F3-E45FF780DB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B1DBF-C4E1-4419-A0FA-BE24BEC9E5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5453B-5DA0-4793-B902-CB27BDD6B7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180A1-9DEE-4A73-9EF6-7C847C3525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909C78-7C37-4DDF-AEAC-75C1FDE5D5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487ED-AFBE-4582-A632-6D02C8713B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73130-CB7B-4A5D-BAD6-1FF7C3505B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8C4F8-F7EA-4D52-82E3-D61BC3D6EF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0049A-7403-4128-94D8-5C0B8AA9F9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098121-C361-4A3C-BC4F-C2ADA0B16EC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1800" y="15840"/>
            <a:ext cx="6127560" cy="8330400"/>
            <a:chOff x="1800" y="15840"/>
            <a:chExt cx="6127560" cy="8330400"/>
          </a:xfrm>
        </p:grpSpPr>
        <p:sp>
          <p:nvSpPr>
            <p:cNvPr id="49" name=""/>
            <p:cNvSpPr/>
            <p:nvPr/>
          </p:nvSpPr>
          <p:spPr>
            <a:xfrm>
              <a:off x="3666960" y="3559320"/>
              <a:ext cx="263520" cy="139212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662120" y="3549600"/>
              <a:ext cx="1203480" cy="140328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"/>
            <p:cNvGrpSpPr/>
            <p:nvPr/>
          </p:nvGrpSpPr>
          <p:grpSpPr>
            <a:xfrm>
              <a:off x="1662120" y="4513320"/>
              <a:ext cx="2224080" cy="442800"/>
              <a:chOff x="1662120" y="4513320"/>
              <a:chExt cx="2224080" cy="442800"/>
            </a:xfrm>
          </p:grpSpPr>
          <p:sp>
            <p:nvSpPr>
              <p:cNvPr id="52" name=""/>
              <p:cNvSpPr/>
              <p:nvPr/>
            </p:nvSpPr>
            <p:spPr>
              <a:xfrm>
                <a:off x="1662120" y="4513320"/>
                <a:ext cx="84240" cy="37620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746360" y="4889520"/>
                <a:ext cx="150840" cy="6660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V="1">
                <a:off x="1897200" y="4866840"/>
                <a:ext cx="385560" cy="8892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V="1">
                <a:off x="2282760" y="4789440"/>
                <a:ext cx="405000" cy="7776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V="1">
                <a:off x="2687760" y="4766760"/>
                <a:ext cx="177840" cy="3348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 flipV="1">
                <a:off x="2865600" y="4723920"/>
                <a:ext cx="220680" cy="4284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086280" y="4724280"/>
                <a:ext cx="587160" cy="0"/>
              </a:xfrm>
              <a:prstGeom prst="line">
                <a:avLst/>
              </a:prstGeom>
              <a:ln w="22320">
                <a:solidFill>
                  <a:srgbClr val="8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676680" y="4724280"/>
                <a:ext cx="73080" cy="14292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749760" y="4867200"/>
                <a:ext cx="136440" cy="4464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1" name=""/>
            <p:cNvGrpSpPr/>
            <p:nvPr/>
          </p:nvGrpSpPr>
          <p:grpSpPr>
            <a:xfrm>
              <a:off x="1677960" y="4446720"/>
              <a:ext cx="2219400" cy="453600"/>
              <a:chOff x="1677960" y="4446720"/>
              <a:chExt cx="2219400" cy="453600"/>
            </a:xfrm>
          </p:grpSpPr>
          <p:sp>
            <p:nvSpPr>
              <p:cNvPr id="62" name=""/>
              <p:cNvSpPr/>
              <p:nvPr/>
            </p:nvSpPr>
            <p:spPr>
              <a:xfrm>
                <a:off x="1677960" y="4446720"/>
                <a:ext cx="68400" cy="43164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1746360" y="4878360"/>
                <a:ext cx="150840" cy="1116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V="1">
                <a:off x="1897200" y="4711320"/>
                <a:ext cx="385560" cy="18900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flipV="1">
                <a:off x="2282760" y="4627440"/>
                <a:ext cx="405000" cy="8424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V="1">
                <a:off x="2687760" y="4602240"/>
                <a:ext cx="182520" cy="2520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flipV="1">
                <a:off x="2870280" y="4589280"/>
                <a:ext cx="216000" cy="1260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3103560" y="4589640"/>
                <a:ext cx="581040" cy="0"/>
              </a:xfrm>
              <a:prstGeom prst="line">
                <a:avLst/>
              </a:prstGeom>
              <a:ln w="22320">
                <a:solidFill>
                  <a:srgbClr val="0000ff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684600" y="4589640"/>
                <a:ext cx="73080" cy="21096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3757680" y="4800600"/>
                <a:ext cx="139680" cy="7776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1" name=""/>
            <p:cNvSpPr/>
            <p:nvPr/>
          </p:nvSpPr>
          <p:spPr>
            <a:xfrm>
              <a:off x="52560" y="15840"/>
              <a:ext cx="40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624120" y="579600"/>
              <a:ext cx="273240" cy="143496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579680" y="581040"/>
              <a:ext cx="1263600" cy="143676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092680" y="241200"/>
              <a:ext cx="1562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-lymphocytes (CD19+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589040" y="579600"/>
              <a:ext cx="0" cy="145080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568520" y="2039760"/>
              <a:ext cx="23176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1593720" y="2039760"/>
              <a:ext cx="0" cy="3816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2052720" y="2039760"/>
              <a:ext cx="0" cy="3816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2509920" y="2039760"/>
              <a:ext cx="0" cy="3816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2970360" y="2039760"/>
              <a:ext cx="0" cy="3816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3427560" y="2039760"/>
              <a:ext cx="0" cy="3816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3886200" y="2039760"/>
              <a:ext cx="0" cy="3816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136520" y="1787400"/>
              <a:ext cx="2713320" cy="252360"/>
            </a:xfrm>
            <a:custGeom>
              <a:avLst/>
              <a:gdLst/>
              <a:ahLst/>
              <a:rect l="l" t="t" r="r" b="b"/>
              <a:pathLst>
                <a:path w="296" h="21">
                  <a:moveTo>
                    <a:pt x="0" y="0"/>
                  </a:moveTo>
                  <a:lnTo>
                    <a:pt x="47" y="11"/>
                  </a:lnTo>
                  <a:lnTo>
                    <a:pt x="57" y="21"/>
                  </a:lnTo>
                  <a:lnTo>
                    <a:pt x="74" y="21"/>
                  </a:lnTo>
                  <a:lnTo>
                    <a:pt x="117" y="21"/>
                  </a:lnTo>
                  <a:lnTo>
                    <a:pt x="161" y="21"/>
                  </a:lnTo>
                  <a:lnTo>
                    <a:pt x="181" y="21"/>
                  </a:lnTo>
                  <a:lnTo>
                    <a:pt x="206" y="17"/>
                  </a:lnTo>
                  <a:lnTo>
                    <a:pt x="280" y="21"/>
                  </a:lnTo>
                  <a:lnTo>
                    <a:pt x="296" y="21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H="1" flipV="1">
              <a:off x="1109160" y="1687320"/>
              <a:ext cx="27000" cy="363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136520" y="1724040"/>
              <a:ext cx="270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H="1">
              <a:off x="1109160" y="1724040"/>
              <a:ext cx="270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H="1" flipV="1">
              <a:off x="1539720" y="1847520"/>
              <a:ext cx="28800" cy="363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568520" y="1884240"/>
              <a:ext cx="252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H="1">
              <a:off x="1539720" y="1884240"/>
              <a:ext cx="288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1568520" y="1847520"/>
              <a:ext cx="25200" cy="363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H="1" flipV="1">
              <a:off x="1630080" y="2004480"/>
              <a:ext cx="2844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658880" y="2039760"/>
              <a:ext cx="288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H="1">
              <a:off x="1630080" y="2039760"/>
              <a:ext cx="2844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1658880" y="2004480"/>
              <a:ext cx="288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H="1" flipV="1">
              <a:off x="1789200" y="2004480"/>
              <a:ext cx="252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814400" y="2039760"/>
              <a:ext cx="288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H="1">
              <a:off x="1789200" y="2039760"/>
              <a:ext cx="252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V="1">
              <a:off x="1814400" y="2004480"/>
              <a:ext cx="288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H="1" flipV="1">
              <a:off x="2180880" y="2004480"/>
              <a:ext cx="2844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209680" y="2039760"/>
              <a:ext cx="2556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H="1">
              <a:off x="2180880" y="2039760"/>
              <a:ext cx="2844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V="1">
              <a:off x="2209680" y="2004480"/>
              <a:ext cx="2556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H="1" flipV="1">
              <a:off x="2582640" y="2004480"/>
              <a:ext cx="2988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612880" y="2039760"/>
              <a:ext cx="270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H="1">
              <a:off x="2582640" y="2039760"/>
              <a:ext cx="2988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2612880" y="2004480"/>
              <a:ext cx="270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H="1" flipV="1">
              <a:off x="2766960" y="2004480"/>
              <a:ext cx="3024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797200" y="2039760"/>
              <a:ext cx="252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H="1">
              <a:off x="2766960" y="2039760"/>
              <a:ext cx="3024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2797200" y="2004480"/>
              <a:ext cx="252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H="1" flipV="1">
              <a:off x="2998440" y="1944360"/>
              <a:ext cx="25560" cy="363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024360" y="1981080"/>
              <a:ext cx="2844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H="1">
              <a:off x="2998440" y="1981080"/>
              <a:ext cx="2556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flipV="1">
              <a:off x="3024360" y="1944360"/>
              <a:ext cx="28440" cy="363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H="1" flipV="1">
              <a:off x="3676680" y="2004480"/>
              <a:ext cx="252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701880" y="2039760"/>
              <a:ext cx="288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H="1">
              <a:off x="3676680" y="2039760"/>
              <a:ext cx="252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flipV="1">
              <a:off x="3701880" y="2004480"/>
              <a:ext cx="288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H="1" flipV="1">
              <a:off x="3822480" y="2004480"/>
              <a:ext cx="2700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849840" y="2039760"/>
              <a:ext cx="2844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H="1">
              <a:off x="3822480" y="2039760"/>
              <a:ext cx="27000" cy="381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V="1">
              <a:off x="3849840" y="2004480"/>
              <a:ext cx="2844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090440" y="1724040"/>
              <a:ext cx="93960" cy="12384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64"/>
                  </a:lnTo>
                  <a:lnTo>
                    <a:pt x="0" y="64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521000" y="1859040"/>
              <a:ext cx="91800" cy="12204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64"/>
                  </a:lnTo>
                  <a:lnTo>
                    <a:pt x="0" y="64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612800" y="1981080"/>
              <a:ext cx="90720" cy="120600"/>
            </a:xfrm>
            <a:custGeom>
              <a:avLst/>
              <a:gdLst/>
              <a:ahLst/>
              <a:rect l="l" t="t" r="r" b="b"/>
              <a:pathLst>
                <a:path w="60" h="63">
                  <a:moveTo>
                    <a:pt x="30" y="0"/>
                  </a:moveTo>
                  <a:lnTo>
                    <a:pt x="60" y="63"/>
                  </a:lnTo>
                  <a:lnTo>
                    <a:pt x="0" y="63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768320" y="1981080"/>
              <a:ext cx="93960" cy="120600"/>
            </a:xfrm>
            <a:custGeom>
              <a:avLst/>
              <a:gdLst/>
              <a:ahLst/>
              <a:rect l="l" t="t" r="r" b="b"/>
              <a:pathLst>
                <a:path w="60" h="63">
                  <a:moveTo>
                    <a:pt x="30" y="0"/>
                  </a:moveTo>
                  <a:lnTo>
                    <a:pt x="60" y="63"/>
                  </a:lnTo>
                  <a:lnTo>
                    <a:pt x="0" y="63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162160" y="1981080"/>
              <a:ext cx="93600" cy="120600"/>
            </a:xfrm>
            <a:custGeom>
              <a:avLst/>
              <a:gdLst/>
              <a:ahLst/>
              <a:rect l="l" t="t" r="r" b="b"/>
              <a:pathLst>
                <a:path w="60" h="63">
                  <a:moveTo>
                    <a:pt x="30" y="0"/>
                  </a:moveTo>
                  <a:lnTo>
                    <a:pt x="60" y="63"/>
                  </a:lnTo>
                  <a:lnTo>
                    <a:pt x="0" y="63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565360" y="1981080"/>
              <a:ext cx="92160" cy="120600"/>
            </a:xfrm>
            <a:custGeom>
              <a:avLst/>
              <a:gdLst/>
              <a:ahLst/>
              <a:rect l="l" t="t" r="r" b="b"/>
              <a:pathLst>
                <a:path w="60" h="63">
                  <a:moveTo>
                    <a:pt x="30" y="0"/>
                  </a:moveTo>
                  <a:lnTo>
                    <a:pt x="60" y="63"/>
                  </a:lnTo>
                  <a:lnTo>
                    <a:pt x="0" y="63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749680" y="1981080"/>
              <a:ext cx="90360" cy="120600"/>
            </a:xfrm>
            <a:custGeom>
              <a:avLst/>
              <a:gdLst/>
              <a:ahLst/>
              <a:rect l="l" t="t" r="r" b="b"/>
              <a:pathLst>
                <a:path w="60" h="63">
                  <a:moveTo>
                    <a:pt x="30" y="0"/>
                  </a:moveTo>
                  <a:lnTo>
                    <a:pt x="60" y="63"/>
                  </a:lnTo>
                  <a:lnTo>
                    <a:pt x="0" y="63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978280" y="1932120"/>
              <a:ext cx="93600" cy="12204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64"/>
                  </a:lnTo>
                  <a:lnTo>
                    <a:pt x="0" y="64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657600" y="1981080"/>
              <a:ext cx="92160" cy="120600"/>
            </a:xfrm>
            <a:custGeom>
              <a:avLst/>
              <a:gdLst/>
              <a:ahLst/>
              <a:rect l="l" t="t" r="r" b="b"/>
              <a:pathLst>
                <a:path w="60" h="63">
                  <a:moveTo>
                    <a:pt x="30" y="0"/>
                  </a:moveTo>
                  <a:lnTo>
                    <a:pt x="60" y="63"/>
                  </a:lnTo>
                  <a:lnTo>
                    <a:pt x="0" y="63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803760" y="1981080"/>
              <a:ext cx="93600" cy="120600"/>
            </a:xfrm>
            <a:custGeom>
              <a:avLst/>
              <a:gdLst/>
              <a:ahLst/>
              <a:rect l="l" t="t" r="r" b="b"/>
              <a:pathLst>
                <a:path w="60" h="63">
                  <a:moveTo>
                    <a:pt x="30" y="0"/>
                  </a:moveTo>
                  <a:lnTo>
                    <a:pt x="60" y="63"/>
                  </a:lnTo>
                  <a:lnTo>
                    <a:pt x="0" y="63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1612800" y="1101600"/>
              <a:ext cx="90720" cy="12240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32"/>
                  </a:lnTo>
                  <a:lnTo>
                    <a:pt x="30" y="64"/>
                  </a:lnTo>
                  <a:lnTo>
                    <a:pt x="0" y="32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768320" y="1015920"/>
              <a:ext cx="93960" cy="12384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32"/>
                  </a:lnTo>
                  <a:lnTo>
                    <a:pt x="30" y="64"/>
                  </a:lnTo>
                  <a:lnTo>
                    <a:pt x="0" y="32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162160" y="1028880"/>
              <a:ext cx="93600" cy="12204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32"/>
                  </a:lnTo>
                  <a:lnTo>
                    <a:pt x="30" y="64"/>
                  </a:lnTo>
                  <a:lnTo>
                    <a:pt x="0" y="32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565360" y="930240"/>
              <a:ext cx="92160" cy="12240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32"/>
                  </a:lnTo>
                  <a:lnTo>
                    <a:pt x="30" y="64"/>
                  </a:lnTo>
                  <a:lnTo>
                    <a:pt x="0" y="32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2749680" y="992160"/>
              <a:ext cx="90360" cy="12240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32"/>
                  </a:lnTo>
                  <a:lnTo>
                    <a:pt x="30" y="64"/>
                  </a:lnTo>
                  <a:lnTo>
                    <a:pt x="0" y="32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978280" y="1052640"/>
              <a:ext cx="93600" cy="12384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32"/>
                  </a:lnTo>
                  <a:lnTo>
                    <a:pt x="30" y="64"/>
                  </a:lnTo>
                  <a:lnTo>
                    <a:pt x="0" y="32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657600" y="1052640"/>
              <a:ext cx="92160" cy="12384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32"/>
                  </a:lnTo>
                  <a:lnTo>
                    <a:pt x="30" y="64"/>
                  </a:lnTo>
                  <a:lnTo>
                    <a:pt x="0" y="32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568520" y="209376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028240" y="209376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454120" y="2093760"/>
              <a:ext cx="19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2913840" y="209376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371040" y="209376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3831480" y="209376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098720" y="1676520"/>
              <a:ext cx="85680" cy="1108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1136520" y="1687320"/>
              <a:ext cx="27000" cy="3636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622520" y="1994040"/>
              <a:ext cx="81000" cy="107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778040" y="1994040"/>
              <a:ext cx="84240" cy="107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173320" y="1994040"/>
              <a:ext cx="82440" cy="107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576520" y="1994040"/>
              <a:ext cx="81000" cy="107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760840" y="1994040"/>
              <a:ext cx="79200" cy="107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2987640" y="1932120"/>
              <a:ext cx="84240" cy="107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3665520" y="1994040"/>
              <a:ext cx="84240" cy="107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3813120" y="1994040"/>
              <a:ext cx="84240" cy="107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1592280" y="2247480"/>
              <a:ext cx="0" cy="182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346760" y="2355840"/>
              <a:ext cx="525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Arial"/>
                </a:rPr>
                <a:t>rAAV5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Arial"/>
                </a:rPr>
                <a:t>pbg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3701880" y="2247480"/>
              <a:ext cx="0" cy="182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438360" y="2360520"/>
              <a:ext cx="525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Arial"/>
                </a:rPr>
                <a:t>rAAV5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Arial"/>
                </a:rPr>
                <a:t>egf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4053600" y="226692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eek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800" y="2989440"/>
              <a:ext cx="40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52560" y="5857920"/>
              <a:ext cx="421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3" name=""/>
            <p:cNvGrpSpPr/>
            <p:nvPr/>
          </p:nvGrpSpPr>
          <p:grpSpPr>
            <a:xfrm>
              <a:off x="969840" y="422280"/>
              <a:ext cx="567000" cy="1824120"/>
              <a:chOff x="969840" y="422280"/>
              <a:chExt cx="567000" cy="1824120"/>
            </a:xfrm>
          </p:grpSpPr>
          <p:sp>
            <p:nvSpPr>
              <p:cNvPr id="164" name=""/>
              <p:cNvSpPr/>
              <p:nvPr/>
            </p:nvSpPr>
            <p:spPr>
              <a:xfrm>
                <a:off x="969840" y="422280"/>
                <a:ext cx="567000" cy="1824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 rot="16200000">
                <a:off x="750240" y="1255680"/>
                <a:ext cx="1179000" cy="152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cell/ml of blood (x10</a:t>
                </a:r>
                <a:r>
                  <a:rPr b="1" lang="en-US" sz="1000" spc="-1" strike="noStrike" baseline="30000">
                    <a:solidFill>
                      <a:srgbClr val="000000"/>
                    </a:solidFill>
                    <a:latin typeface="Times New Roman"/>
                  </a:rPr>
                  <a:t>6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6" name=""/>
            <p:cNvSpPr/>
            <p:nvPr/>
          </p:nvSpPr>
          <p:spPr>
            <a:xfrm>
              <a:off x="1563840" y="1554120"/>
              <a:ext cx="2700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1563840" y="1077840"/>
              <a:ext cx="2700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1563840" y="588960"/>
              <a:ext cx="2700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1455120" y="1455840"/>
              <a:ext cx="64800" cy="152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1455120" y="981000"/>
              <a:ext cx="64800" cy="152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455120" y="492120"/>
              <a:ext cx="64800" cy="152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644120" y="500544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2088720" y="500544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2510640" y="500544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2955240" y="500544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3402720" y="500544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3852000" y="500544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113560" y="3222720"/>
              <a:ext cx="842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D4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T cell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1677960" y="3570120"/>
              <a:ext cx="0" cy="139716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1677960" y="4967280"/>
              <a:ext cx="224784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flipV="1">
              <a:off x="1681200" y="4966920"/>
              <a:ext cx="0" cy="334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flipV="1">
              <a:off x="2128680" y="4966920"/>
              <a:ext cx="0" cy="334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flipV="1">
              <a:off x="2585880" y="4966920"/>
              <a:ext cx="0" cy="334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flipV="1">
              <a:off x="3032280" y="4966920"/>
              <a:ext cx="0" cy="334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 flipV="1">
              <a:off x="3478320" y="4966920"/>
              <a:ext cx="0" cy="334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 flipV="1">
              <a:off x="3925800" y="4966920"/>
              <a:ext cx="0" cy="334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603440" y="4368960"/>
              <a:ext cx="117360" cy="982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 flipH="1" flipV="1">
              <a:off x="1618920" y="4377960"/>
              <a:ext cx="3636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1655640" y="4411800"/>
              <a:ext cx="3816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 flipH="1">
              <a:off x="1618920" y="4411800"/>
              <a:ext cx="36360" cy="349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flipV="1">
              <a:off x="1655640" y="4377960"/>
              <a:ext cx="3816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1693800" y="4822920"/>
              <a:ext cx="115920" cy="1000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 flipH="1" flipV="1">
              <a:off x="1704600" y="4834080"/>
              <a:ext cx="4140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1746360" y="4867200"/>
              <a:ext cx="3960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 flipH="1">
              <a:off x="1704600" y="4867200"/>
              <a:ext cx="4140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 flipV="1">
              <a:off x="1746360" y="4834080"/>
              <a:ext cx="3960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1846440" y="4834080"/>
              <a:ext cx="115560" cy="101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flipH="1" flipV="1">
              <a:off x="1860480" y="4846680"/>
              <a:ext cx="36720" cy="316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1897200" y="4878360"/>
              <a:ext cx="3960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 flipH="1">
              <a:off x="1860480" y="4878360"/>
              <a:ext cx="3672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 flipV="1">
              <a:off x="1897200" y="4846680"/>
              <a:ext cx="39600" cy="316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2230560" y="4668840"/>
              <a:ext cx="114120" cy="982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 flipH="1" flipV="1">
              <a:off x="2243160" y="4677840"/>
              <a:ext cx="3960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2282760" y="4711680"/>
              <a:ext cx="3816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 flipH="1">
              <a:off x="2243160" y="4711680"/>
              <a:ext cx="3960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2282760" y="4677840"/>
              <a:ext cx="3816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2638440" y="4579920"/>
              <a:ext cx="114120" cy="982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flipH="1" flipV="1">
              <a:off x="2651040" y="4589640"/>
              <a:ext cx="3672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2687760" y="4622760"/>
              <a:ext cx="4104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flipH="1">
              <a:off x="2651040" y="4622760"/>
              <a:ext cx="3672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 flipV="1">
              <a:off x="2687760" y="4589640"/>
              <a:ext cx="4104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2816280" y="4556160"/>
              <a:ext cx="114120" cy="1000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 flipH="1" flipV="1">
              <a:off x="2830680" y="4568400"/>
              <a:ext cx="3960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2870280" y="4602240"/>
              <a:ext cx="3636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flipH="1">
              <a:off x="2830680" y="4602240"/>
              <a:ext cx="3960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 flipV="1">
              <a:off x="2870280" y="4568400"/>
              <a:ext cx="3636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3032280" y="4546440"/>
              <a:ext cx="115560" cy="986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flipH="1" flipV="1">
              <a:off x="3045960" y="4555800"/>
              <a:ext cx="3996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3086280" y="4589640"/>
              <a:ext cx="3636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 flipH="1">
              <a:off x="3045960" y="4589640"/>
              <a:ext cx="3996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3086280" y="4555800"/>
              <a:ext cx="3636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3697200" y="4745160"/>
              <a:ext cx="115920" cy="101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H="1" flipV="1">
              <a:off x="3709800" y="4757760"/>
              <a:ext cx="36360" cy="316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3746520" y="4789440"/>
              <a:ext cx="3960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H="1">
              <a:off x="3709800" y="4789440"/>
              <a:ext cx="3636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flipV="1">
              <a:off x="3746520" y="4757760"/>
              <a:ext cx="39600" cy="316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3836880" y="4822920"/>
              <a:ext cx="114480" cy="1000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 flipH="1" flipV="1">
              <a:off x="3848040" y="4834080"/>
              <a:ext cx="3816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3886200" y="4867200"/>
              <a:ext cx="3960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 flipH="1">
              <a:off x="3848040" y="4867200"/>
              <a:ext cx="38160" cy="3348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 flipV="1">
              <a:off x="3886200" y="4834080"/>
              <a:ext cx="39600" cy="33120"/>
            </a:xfrm>
            <a:prstGeom prst="line">
              <a:avLst/>
            </a:prstGeom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1592280" y="4446720"/>
              <a:ext cx="128520" cy="109440"/>
            </a:xfrm>
            <a:custGeom>
              <a:avLst/>
              <a:gdLst/>
              <a:ahLst/>
              <a:rect l="l" t="t" r="r" b="b"/>
              <a:pathLst>
                <a:path w="76" h="63">
                  <a:moveTo>
                    <a:pt x="38" y="0"/>
                  </a:moveTo>
                  <a:lnTo>
                    <a:pt x="76" y="63"/>
                  </a:lnTo>
                  <a:lnTo>
                    <a:pt x="0" y="63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1681200" y="4813200"/>
              <a:ext cx="128520" cy="109800"/>
            </a:xfrm>
            <a:custGeom>
              <a:avLst/>
              <a:gdLst/>
              <a:ahLst/>
              <a:rect l="l" t="t" r="r" b="b"/>
              <a:pathLst>
                <a:path w="76" h="63">
                  <a:moveTo>
                    <a:pt x="38" y="0"/>
                  </a:moveTo>
                  <a:lnTo>
                    <a:pt x="76" y="63"/>
                  </a:lnTo>
                  <a:lnTo>
                    <a:pt x="0" y="63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1836720" y="4889520"/>
              <a:ext cx="125280" cy="111240"/>
            </a:xfrm>
            <a:custGeom>
              <a:avLst/>
              <a:gdLst/>
              <a:ahLst/>
              <a:rect l="l" t="t" r="r" b="b"/>
              <a:pathLst>
                <a:path w="76" h="64">
                  <a:moveTo>
                    <a:pt x="38" y="0"/>
                  </a:moveTo>
                  <a:lnTo>
                    <a:pt x="76" y="64"/>
                  </a:lnTo>
                  <a:lnTo>
                    <a:pt x="0" y="64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219400" y="4800600"/>
              <a:ext cx="125280" cy="111240"/>
            </a:xfrm>
            <a:custGeom>
              <a:avLst/>
              <a:gdLst/>
              <a:ahLst/>
              <a:rect l="l" t="t" r="r" b="b"/>
              <a:pathLst>
                <a:path w="76" h="64">
                  <a:moveTo>
                    <a:pt x="38" y="0"/>
                  </a:moveTo>
                  <a:lnTo>
                    <a:pt x="76" y="64"/>
                  </a:lnTo>
                  <a:lnTo>
                    <a:pt x="0" y="64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2627280" y="4724280"/>
              <a:ext cx="125280" cy="109800"/>
            </a:xfrm>
            <a:custGeom>
              <a:avLst/>
              <a:gdLst/>
              <a:ahLst/>
              <a:rect l="l" t="t" r="r" b="b"/>
              <a:pathLst>
                <a:path w="76" h="63">
                  <a:moveTo>
                    <a:pt x="38" y="0"/>
                  </a:moveTo>
                  <a:lnTo>
                    <a:pt x="76" y="63"/>
                  </a:lnTo>
                  <a:lnTo>
                    <a:pt x="0" y="63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2805120" y="4700520"/>
              <a:ext cx="125280" cy="112680"/>
            </a:xfrm>
            <a:custGeom>
              <a:avLst/>
              <a:gdLst/>
              <a:ahLst/>
              <a:rect l="l" t="t" r="r" b="b"/>
              <a:pathLst>
                <a:path w="76" h="64">
                  <a:moveTo>
                    <a:pt x="38" y="0"/>
                  </a:moveTo>
                  <a:lnTo>
                    <a:pt x="76" y="64"/>
                  </a:lnTo>
                  <a:lnTo>
                    <a:pt x="0" y="64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3021120" y="4668840"/>
              <a:ext cx="126720" cy="109440"/>
            </a:xfrm>
            <a:custGeom>
              <a:avLst/>
              <a:gdLst/>
              <a:ahLst/>
              <a:rect l="l" t="t" r="r" b="b"/>
              <a:pathLst>
                <a:path w="77" h="63">
                  <a:moveTo>
                    <a:pt x="39" y="0"/>
                  </a:moveTo>
                  <a:lnTo>
                    <a:pt x="77" y="63"/>
                  </a:lnTo>
                  <a:lnTo>
                    <a:pt x="0" y="63"/>
                  </a:lnTo>
                  <a:lnTo>
                    <a:pt x="39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3684600" y="4789440"/>
              <a:ext cx="128520" cy="111240"/>
            </a:xfrm>
            <a:custGeom>
              <a:avLst/>
              <a:gdLst/>
              <a:ahLst/>
              <a:rect l="l" t="t" r="r" b="b"/>
              <a:pathLst>
                <a:path w="77" h="63">
                  <a:moveTo>
                    <a:pt x="38" y="0"/>
                  </a:moveTo>
                  <a:lnTo>
                    <a:pt x="77" y="63"/>
                  </a:lnTo>
                  <a:lnTo>
                    <a:pt x="0" y="63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3822840" y="4846680"/>
              <a:ext cx="128520" cy="109440"/>
            </a:xfrm>
            <a:custGeom>
              <a:avLst/>
              <a:gdLst/>
              <a:ahLst/>
              <a:rect l="l" t="t" r="r" b="b"/>
              <a:pathLst>
                <a:path w="76" h="63">
                  <a:moveTo>
                    <a:pt x="38" y="0"/>
                  </a:moveTo>
                  <a:lnTo>
                    <a:pt x="76" y="63"/>
                  </a:lnTo>
                  <a:lnTo>
                    <a:pt x="0" y="63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1592280" y="4402080"/>
              <a:ext cx="128520" cy="111240"/>
            </a:xfrm>
            <a:custGeom>
              <a:avLst/>
              <a:gdLst/>
              <a:ahLst/>
              <a:rect l="l" t="t" r="r" b="b"/>
              <a:pathLst>
                <a:path w="76" h="64">
                  <a:moveTo>
                    <a:pt x="38" y="0"/>
                  </a:moveTo>
                  <a:lnTo>
                    <a:pt x="76" y="32"/>
                  </a:lnTo>
                  <a:lnTo>
                    <a:pt x="38" y="64"/>
                  </a:lnTo>
                  <a:lnTo>
                    <a:pt x="0" y="32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1681200" y="4079880"/>
              <a:ext cx="128520" cy="111240"/>
            </a:xfrm>
            <a:custGeom>
              <a:avLst/>
              <a:gdLst/>
              <a:ahLst/>
              <a:rect l="l" t="t" r="r" b="b"/>
              <a:pathLst>
                <a:path w="76" h="63">
                  <a:moveTo>
                    <a:pt x="38" y="0"/>
                  </a:moveTo>
                  <a:lnTo>
                    <a:pt x="76" y="31"/>
                  </a:lnTo>
                  <a:lnTo>
                    <a:pt x="38" y="63"/>
                  </a:lnTo>
                  <a:lnTo>
                    <a:pt x="0" y="31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1836720" y="3979800"/>
              <a:ext cx="125280" cy="111240"/>
            </a:xfrm>
            <a:custGeom>
              <a:avLst/>
              <a:gdLst/>
              <a:ahLst/>
              <a:rect l="l" t="t" r="r" b="b"/>
              <a:pathLst>
                <a:path w="76" h="64">
                  <a:moveTo>
                    <a:pt x="38" y="0"/>
                  </a:moveTo>
                  <a:lnTo>
                    <a:pt x="76" y="32"/>
                  </a:lnTo>
                  <a:lnTo>
                    <a:pt x="38" y="64"/>
                  </a:lnTo>
                  <a:lnTo>
                    <a:pt x="0" y="32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2219400" y="3801960"/>
              <a:ext cx="125280" cy="111240"/>
            </a:xfrm>
            <a:custGeom>
              <a:avLst/>
              <a:gdLst/>
              <a:ahLst/>
              <a:rect l="l" t="t" r="r" b="b"/>
              <a:pathLst>
                <a:path w="76" h="64">
                  <a:moveTo>
                    <a:pt x="38" y="0"/>
                  </a:moveTo>
                  <a:lnTo>
                    <a:pt x="76" y="32"/>
                  </a:lnTo>
                  <a:lnTo>
                    <a:pt x="38" y="64"/>
                  </a:lnTo>
                  <a:lnTo>
                    <a:pt x="0" y="32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2627280" y="3747960"/>
              <a:ext cx="125280" cy="109800"/>
            </a:xfrm>
            <a:custGeom>
              <a:avLst/>
              <a:gdLst/>
              <a:ahLst/>
              <a:rect l="l" t="t" r="r" b="b"/>
              <a:pathLst>
                <a:path w="76" h="63">
                  <a:moveTo>
                    <a:pt x="38" y="0"/>
                  </a:moveTo>
                  <a:lnTo>
                    <a:pt x="76" y="31"/>
                  </a:lnTo>
                  <a:lnTo>
                    <a:pt x="38" y="63"/>
                  </a:lnTo>
                  <a:lnTo>
                    <a:pt x="0" y="31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2805120" y="3813120"/>
              <a:ext cx="125280" cy="111240"/>
            </a:xfrm>
            <a:custGeom>
              <a:avLst/>
              <a:gdLst/>
              <a:ahLst/>
              <a:rect l="l" t="t" r="r" b="b"/>
              <a:pathLst>
                <a:path w="76" h="63">
                  <a:moveTo>
                    <a:pt x="38" y="0"/>
                  </a:moveTo>
                  <a:lnTo>
                    <a:pt x="76" y="32"/>
                  </a:lnTo>
                  <a:lnTo>
                    <a:pt x="38" y="63"/>
                  </a:lnTo>
                  <a:lnTo>
                    <a:pt x="0" y="32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3021120" y="3870360"/>
              <a:ext cx="126720" cy="109440"/>
            </a:xfrm>
            <a:custGeom>
              <a:avLst/>
              <a:gdLst/>
              <a:ahLst/>
              <a:rect l="l" t="t" r="r" b="b"/>
              <a:pathLst>
                <a:path w="77" h="63">
                  <a:moveTo>
                    <a:pt x="39" y="0"/>
                  </a:moveTo>
                  <a:lnTo>
                    <a:pt x="77" y="31"/>
                  </a:lnTo>
                  <a:lnTo>
                    <a:pt x="39" y="63"/>
                  </a:lnTo>
                  <a:lnTo>
                    <a:pt x="0" y="31"/>
                  </a:lnTo>
                  <a:lnTo>
                    <a:pt x="39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3684600" y="3870360"/>
              <a:ext cx="128520" cy="109440"/>
            </a:xfrm>
            <a:custGeom>
              <a:avLst/>
              <a:gdLst/>
              <a:ahLst/>
              <a:rect l="l" t="t" r="r" b="b"/>
              <a:pathLst>
                <a:path w="77" h="63">
                  <a:moveTo>
                    <a:pt x="38" y="0"/>
                  </a:moveTo>
                  <a:lnTo>
                    <a:pt x="77" y="31"/>
                  </a:lnTo>
                  <a:lnTo>
                    <a:pt x="38" y="63"/>
                  </a:lnTo>
                  <a:lnTo>
                    <a:pt x="0" y="31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49" name=""/>
            <p:cNvGrpSpPr/>
            <p:nvPr/>
          </p:nvGrpSpPr>
          <p:grpSpPr>
            <a:xfrm>
              <a:off x="1419840" y="5167440"/>
              <a:ext cx="525240" cy="443520"/>
              <a:chOff x="1419840" y="5167440"/>
              <a:chExt cx="525240" cy="443520"/>
            </a:xfrm>
          </p:grpSpPr>
          <p:sp>
            <p:nvSpPr>
              <p:cNvPr id="250" name=""/>
              <p:cNvSpPr/>
              <p:nvPr/>
            </p:nvSpPr>
            <p:spPr>
              <a:xfrm flipV="1">
                <a:off x="1678680" y="5167440"/>
                <a:ext cx="0" cy="167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1419840" y="5273640"/>
                <a:ext cx="525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rAAV5-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pbg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2" name=""/>
            <p:cNvGrpSpPr/>
            <p:nvPr/>
          </p:nvGrpSpPr>
          <p:grpSpPr>
            <a:xfrm>
              <a:off x="3506760" y="5167440"/>
              <a:ext cx="525240" cy="448560"/>
              <a:chOff x="3506760" y="5167440"/>
              <a:chExt cx="525240" cy="448560"/>
            </a:xfrm>
          </p:grpSpPr>
          <p:sp>
            <p:nvSpPr>
              <p:cNvPr id="253" name=""/>
              <p:cNvSpPr/>
              <p:nvPr/>
            </p:nvSpPr>
            <p:spPr>
              <a:xfrm flipV="1">
                <a:off x="3739680" y="5167440"/>
                <a:ext cx="0" cy="167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3506760" y="5278680"/>
                <a:ext cx="525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rAAV5-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egf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5" name=""/>
            <p:cNvSpPr/>
            <p:nvPr/>
          </p:nvSpPr>
          <p:spPr>
            <a:xfrm>
              <a:off x="4045680" y="516744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eek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1158840" y="4340160"/>
              <a:ext cx="406440" cy="295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1644480" y="4700520"/>
              <a:ext cx="2880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1644480" y="4133880"/>
              <a:ext cx="2880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1644480" y="3855960"/>
              <a:ext cx="2880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1644480" y="3579840"/>
              <a:ext cx="2880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1" name=""/>
            <p:cNvGrpSpPr/>
            <p:nvPr/>
          </p:nvGrpSpPr>
          <p:grpSpPr>
            <a:xfrm>
              <a:off x="1235160" y="3505320"/>
              <a:ext cx="339120" cy="1324440"/>
              <a:chOff x="1235160" y="3505320"/>
              <a:chExt cx="339120" cy="1324440"/>
            </a:xfrm>
          </p:grpSpPr>
          <p:sp>
            <p:nvSpPr>
              <p:cNvPr id="262" name=""/>
              <p:cNvSpPr/>
              <p:nvPr/>
            </p:nvSpPr>
            <p:spPr>
              <a:xfrm>
                <a:off x="1413360" y="462744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1413360" y="434952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1413360" y="406080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1413360" y="378288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2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1413360" y="350532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2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 rot="16200000">
                <a:off x="721800" y="4163760"/>
                <a:ext cx="1179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cell/ml of blood (x10</a:t>
                </a:r>
                <a:r>
                  <a:rPr b="1" lang="en-US" sz="1000" spc="-1" strike="noStrike" baseline="30000">
                    <a:solidFill>
                      <a:srgbClr val="000000"/>
                    </a:solidFill>
                    <a:latin typeface="Times New Roman"/>
                  </a:rPr>
                  <a:t>6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68" name=""/>
            <p:cNvSpPr/>
            <p:nvPr/>
          </p:nvSpPr>
          <p:spPr>
            <a:xfrm>
              <a:off x="3662280" y="6326280"/>
              <a:ext cx="260280" cy="136836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1704960" y="6310440"/>
              <a:ext cx="1184400" cy="1374480"/>
            </a:xfrm>
            <a:prstGeom prst="rect">
              <a:avLst/>
            </a:prstGeom>
            <a:blipFill rotWithShape="0">
              <a:blip r:embed="rId6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094480" y="5986440"/>
              <a:ext cx="842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D8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T cell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1690560" y="6327720"/>
              <a:ext cx="0" cy="137340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1703520" y="7701120"/>
              <a:ext cx="22129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flipV="1">
              <a:off x="1697040" y="7701120"/>
              <a:ext cx="0" cy="316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 flipV="1">
              <a:off x="2133720" y="7701120"/>
              <a:ext cx="0" cy="316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 flipV="1">
              <a:off x="2581200" y="7701120"/>
              <a:ext cx="0" cy="316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 flipV="1">
              <a:off x="3032280" y="7701120"/>
              <a:ext cx="0" cy="316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 flipV="1">
              <a:off x="3468600" y="7701120"/>
              <a:ext cx="0" cy="316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 flipV="1">
              <a:off x="3916440" y="7701120"/>
              <a:ext cx="0" cy="3168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1636560" y="6678720"/>
              <a:ext cx="71640" cy="66600"/>
            </a:xfrm>
            <a:custGeom>
              <a:avLst/>
              <a:gdLst/>
              <a:ahLst/>
              <a:rect l="l" t="t" r="r" b="b"/>
              <a:pathLst>
                <a:path w="45" h="38">
                  <a:moveTo>
                    <a:pt x="22" y="0"/>
                  </a:moveTo>
                  <a:lnTo>
                    <a:pt x="45" y="38"/>
                  </a:lnTo>
                  <a:lnTo>
                    <a:pt x="0" y="38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1720800" y="7238880"/>
              <a:ext cx="73080" cy="68400"/>
            </a:xfrm>
            <a:custGeom>
              <a:avLst/>
              <a:gdLst/>
              <a:ahLst/>
              <a:rect l="l" t="t" r="r" b="b"/>
              <a:pathLst>
                <a:path w="45" h="38">
                  <a:moveTo>
                    <a:pt x="23" y="0"/>
                  </a:moveTo>
                  <a:lnTo>
                    <a:pt x="45" y="38"/>
                  </a:lnTo>
                  <a:lnTo>
                    <a:pt x="0" y="38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1866960" y="6921360"/>
              <a:ext cx="71280" cy="65160"/>
            </a:xfrm>
            <a:custGeom>
              <a:avLst/>
              <a:gdLst/>
              <a:ahLst/>
              <a:rect l="l" t="t" r="r" b="b"/>
              <a:pathLst>
                <a:path w="45" h="38">
                  <a:moveTo>
                    <a:pt x="22" y="0"/>
                  </a:moveTo>
                  <a:lnTo>
                    <a:pt x="45" y="38"/>
                  </a:lnTo>
                  <a:lnTo>
                    <a:pt x="0" y="38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254320" y="6878520"/>
              <a:ext cx="73080" cy="65160"/>
            </a:xfrm>
            <a:custGeom>
              <a:avLst/>
              <a:gdLst/>
              <a:ahLst/>
              <a:rect l="l" t="t" r="r" b="b"/>
              <a:pathLst>
                <a:path w="44" h="38">
                  <a:moveTo>
                    <a:pt x="22" y="0"/>
                  </a:moveTo>
                  <a:lnTo>
                    <a:pt x="44" y="38"/>
                  </a:lnTo>
                  <a:lnTo>
                    <a:pt x="0" y="38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2643120" y="6845400"/>
              <a:ext cx="71640" cy="65160"/>
            </a:xfrm>
            <a:custGeom>
              <a:avLst/>
              <a:gdLst/>
              <a:ahLst/>
              <a:rect l="l" t="t" r="r" b="b"/>
              <a:pathLst>
                <a:path w="45" h="38">
                  <a:moveTo>
                    <a:pt x="23" y="0"/>
                  </a:moveTo>
                  <a:lnTo>
                    <a:pt x="45" y="38"/>
                  </a:lnTo>
                  <a:lnTo>
                    <a:pt x="0" y="38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2824200" y="6624720"/>
              <a:ext cx="71280" cy="66600"/>
            </a:xfrm>
            <a:custGeom>
              <a:avLst/>
              <a:gdLst/>
              <a:ahLst/>
              <a:rect l="l" t="t" r="r" b="b"/>
              <a:pathLst>
                <a:path w="45" h="39">
                  <a:moveTo>
                    <a:pt x="23" y="0"/>
                  </a:moveTo>
                  <a:lnTo>
                    <a:pt x="45" y="39"/>
                  </a:lnTo>
                  <a:lnTo>
                    <a:pt x="0" y="39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3043080" y="6711840"/>
              <a:ext cx="73080" cy="66960"/>
            </a:xfrm>
            <a:custGeom>
              <a:avLst/>
              <a:gdLst/>
              <a:ahLst/>
              <a:rect l="l" t="t" r="r" b="b"/>
              <a:pathLst>
                <a:path w="44" h="38">
                  <a:moveTo>
                    <a:pt x="22" y="0"/>
                  </a:moveTo>
                  <a:lnTo>
                    <a:pt x="44" y="38"/>
                  </a:lnTo>
                  <a:lnTo>
                    <a:pt x="0" y="38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3699000" y="7570800"/>
              <a:ext cx="69840" cy="65160"/>
            </a:xfrm>
            <a:custGeom>
              <a:avLst/>
              <a:gdLst/>
              <a:ahLst/>
              <a:rect l="l" t="t" r="r" b="b"/>
              <a:pathLst>
                <a:path w="44" h="38">
                  <a:moveTo>
                    <a:pt x="22" y="0"/>
                  </a:moveTo>
                  <a:lnTo>
                    <a:pt x="44" y="38"/>
                  </a:lnTo>
                  <a:lnTo>
                    <a:pt x="0" y="38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3844800" y="7042320"/>
              <a:ext cx="71640" cy="64800"/>
            </a:xfrm>
            <a:custGeom>
              <a:avLst/>
              <a:gdLst/>
              <a:ahLst/>
              <a:rect l="l" t="t" r="r" b="b"/>
              <a:pathLst>
                <a:path w="45" h="38">
                  <a:moveTo>
                    <a:pt x="23" y="0"/>
                  </a:moveTo>
                  <a:lnTo>
                    <a:pt x="45" y="38"/>
                  </a:lnTo>
                  <a:lnTo>
                    <a:pt x="0" y="38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800000"/>
            </a:solidFill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1636560" y="6813720"/>
              <a:ext cx="60480" cy="52200"/>
            </a:xfrm>
            <a:prstGeom prst="rect">
              <a:avLst/>
            </a:prstGeom>
            <a:solidFill>
              <a:srgbClr val="0000ff"/>
            </a:solidFill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1720800" y="7448400"/>
              <a:ext cx="61920" cy="54000"/>
            </a:xfrm>
            <a:prstGeom prst="rect">
              <a:avLst/>
            </a:prstGeom>
            <a:solidFill>
              <a:srgbClr val="0000ff"/>
            </a:solidFill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1866960" y="7338960"/>
              <a:ext cx="61920" cy="55440"/>
            </a:xfrm>
            <a:prstGeom prst="rect">
              <a:avLst/>
            </a:prstGeom>
            <a:solidFill>
              <a:srgbClr val="0000ff"/>
            </a:solidFill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2254320" y="7259760"/>
              <a:ext cx="60120" cy="56880"/>
            </a:xfrm>
            <a:prstGeom prst="rect">
              <a:avLst/>
            </a:prstGeom>
            <a:solidFill>
              <a:srgbClr val="0000ff"/>
            </a:solidFill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643120" y="7042320"/>
              <a:ext cx="61920" cy="55440"/>
            </a:xfrm>
            <a:prstGeom prst="rect">
              <a:avLst/>
            </a:prstGeom>
            <a:solidFill>
              <a:srgbClr val="0000ff"/>
            </a:solidFill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2824200" y="6975360"/>
              <a:ext cx="63360" cy="57240"/>
            </a:xfrm>
            <a:prstGeom prst="rect">
              <a:avLst/>
            </a:prstGeom>
            <a:solidFill>
              <a:srgbClr val="0000ff"/>
            </a:solidFill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3043080" y="7064280"/>
              <a:ext cx="60480" cy="55800"/>
            </a:xfrm>
            <a:prstGeom prst="rect">
              <a:avLst/>
            </a:prstGeom>
            <a:solidFill>
              <a:srgbClr val="0000ff"/>
            </a:solidFill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3699000" y="7629480"/>
              <a:ext cx="58680" cy="52560"/>
            </a:xfrm>
            <a:prstGeom prst="rect">
              <a:avLst/>
            </a:prstGeom>
            <a:solidFill>
              <a:srgbClr val="0000ff"/>
            </a:solidFill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3844800" y="7350120"/>
              <a:ext cx="60480" cy="54000"/>
            </a:xfrm>
            <a:prstGeom prst="rect">
              <a:avLst/>
            </a:prstGeom>
            <a:solidFill>
              <a:srgbClr val="0000ff"/>
            </a:solidFill>
            <a:ln w="223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1612800" y="7238880"/>
              <a:ext cx="120600" cy="111240"/>
            </a:xfrm>
            <a:custGeom>
              <a:avLst/>
              <a:gdLst/>
              <a:ahLst/>
              <a:rect l="l" t="t" r="r" b="b"/>
              <a:pathLst>
                <a:path w="75" h="63">
                  <a:moveTo>
                    <a:pt x="37" y="0"/>
                  </a:moveTo>
                  <a:lnTo>
                    <a:pt x="75" y="32"/>
                  </a:lnTo>
                  <a:lnTo>
                    <a:pt x="37" y="63"/>
                  </a:lnTo>
                  <a:lnTo>
                    <a:pt x="0" y="32"/>
                  </a:lnTo>
                  <a:lnTo>
                    <a:pt x="37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1697040" y="6832440"/>
              <a:ext cx="120600" cy="111240"/>
            </a:xfrm>
            <a:custGeom>
              <a:avLst/>
              <a:gdLst/>
              <a:ahLst/>
              <a:rect l="l" t="t" r="r" b="b"/>
              <a:pathLst>
                <a:path w="75" h="64">
                  <a:moveTo>
                    <a:pt x="38" y="0"/>
                  </a:moveTo>
                  <a:lnTo>
                    <a:pt x="75" y="32"/>
                  </a:lnTo>
                  <a:lnTo>
                    <a:pt x="38" y="64"/>
                  </a:lnTo>
                  <a:lnTo>
                    <a:pt x="0" y="32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1843200" y="6813720"/>
              <a:ext cx="118800" cy="107640"/>
            </a:xfrm>
            <a:custGeom>
              <a:avLst/>
              <a:gdLst/>
              <a:ahLst/>
              <a:rect l="l" t="t" r="r" b="b"/>
              <a:pathLst>
                <a:path w="74" h="63">
                  <a:moveTo>
                    <a:pt x="37" y="0"/>
                  </a:moveTo>
                  <a:lnTo>
                    <a:pt x="74" y="31"/>
                  </a:lnTo>
                  <a:lnTo>
                    <a:pt x="37" y="63"/>
                  </a:lnTo>
                  <a:lnTo>
                    <a:pt x="0" y="31"/>
                  </a:lnTo>
                  <a:lnTo>
                    <a:pt x="37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2230560" y="6800760"/>
              <a:ext cx="120600" cy="109800"/>
            </a:xfrm>
            <a:custGeom>
              <a:avLst/>
              <a:gdLst/>
              <a:ahLst/>
              <a:rect l="l" t="t" r="r" b="b"/>
              <a:pathLst>
                <a:path w="74" h="64">
                  <a:moveTo>
                    <a:pt x="37" y="0"/>
                  </a:moveTo>
                  <a:lnTo>
                    <a:pt x="74" y="32"/>
                  </a:lnTo>
                  <a:lnTo>
                    <a:pt x="37" y="64"/>
                  </a:lnTo>
                  <a:lnTo>
                    <a:pt x="0" y="32"/>
                  </a:lnTo>
                  <a:lnTo>
                    <a:pt x="37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2619360" y="6647040"/>
              <a:ext cx="120600" cy="110880"/>
            </a:xfrm>
            <a:custGeom>
              <a:avLst/>
              <a:gdLst/>
              <a:ahLst/>
              <a:rect l="l" t="t" r="r" b="b"/>
              <a:pathLst>
                <a:path w="75" h="64">
                  <a:moveTo>
                    <a:pt x="38" y="0"/>
                  </a:moveTo>
                  <a:lnTo>
                    <a:pt x="75" y="32"/>
                  </a:lnTo>
                  <a:lnTo>
                    <a:pt x="38" y="64"/>
                  </a:lnTo>
                  <a:lnTo>
                    <a:pt x="0" y="32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2800440" y="6865920"/>
              <a:ext cx="122040" cy="109440"/>
            </a:xfrm>
            <a:custGeom>
              <a:avLst/>
              <a:gdLst/>
              <a:ahLst/>
              <a:rect l="l" t="t" r="r" b="b"/>
              <a:pathLst>
                <a:path w="75" h="64">
                  <a:moveTo>
                    <a:pt x="38" y="0"/>
                  </a:moveTo>
                  <a:lnTo>
                    <a:pt x="75" y="32"/>
                  </a:lnTo>
                  <a:lnTo>
                    <a:pt x="38" y="64"/>
                  </a:lnTo>
                  <a:lnTo>
                    <a:pt x="0" y="32"/>
                  </a:lnTo>
                  <a:lnTo>
                    <a:pt x="38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3021120" y="6986520"/>
              <a:ext cx="118800" cy="111240"/>
            </a:xfrm>
            <a:custGeom>
              <a:avLst/>
              <a:gdLst/>
              <a:ahLst/>
              <a:rect l="l" t="t" r="r" b="b"/>
              <a:pathLst>
                <a:path w="74" h="64">
                  <a:moveTo>
                    <a:pt x="37" y="0"/>
                  </a:moveTo>
                  <a:lnTo>
                    <a:pt x="74" y="32"/>
                  </a:lnTo>
                  <a:lnTo>
                    <a:pt x="37" y="64"/>
                  </a:lnTo>
                  <a:lnTo>
                    <a:pt x="0" y="32"/>
                  </a:lnTo>
                  <a:lnTo>
                    <a:pt x="37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3673440" y="6986520"/>
              <a:ext cx="120600" cy="111240"/>
            </a:xfrm>
            <a:custGeom>
              <a:avLst/>
              <a:gdLst/>
              <a:ahLst/>
              <a:rect l="l" t="t" r="r" b="b"/>
              <a:pathLst>
                <a:path w="74" h="64">
                  <a:moveTo>
                    <a:pt x="37" y="0"/>
                  </a:moveTo>
                  <a:lnTo>
                    <a:pt x="74" y="32"/>
                  </a:lnTo>
                  <a:lnTo>
                    <a:pt x="37" y="64"/>
                  </a:lnTo>
                  <a:lnTo>
                    <a:pt x="0" y="32"/>
                  </a:lnTo>
                  <a:lnTo>
                    <a:pt x="37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1660680" y="772632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2098080" y="772632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2506680" y="77263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2958480" y="77263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3391560" y="77263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3844080" y="77263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11" name=""/>
            <p:cNvGrpSpPr/>
            <p:nvPr/>
          </p:nvGrpSpPr>
          <p:grpSpPr>
            <a:xfrm>
              <a:off x="1447560" y="7897320"/>
              <a:ext cx="525240" cy="443880"/>
              <a:chOff x="1447560" y="7897320"/>
              <a:chExt cx="525240" cy="443880"/>
            </a:xfrm>
          </p:grpSpPr>
          <p:sp>
            <p:nvSpPr>
              <p:cNvPr id="312" name=""/>
              <p:cNvSpPr/>
              <p:nvPr/>
            </p:nvSpPr>
            <p:spPr>
              <a:xfrm flipV="1">
                <a:off x="1705680" y="7897320"/>
                <a:ext cx="0" cy="164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1447560" y="8003880"/>
                <a:ext cx="525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rAAV5-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pbg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4" name=""/>
            <p:cNvGrpSpPr/>
            <p:nvPr/>
          </p:nvGrpSpPr>
          <p:grpSpPr>
            <a:xfrm>
              <a:off x="3485880" y="7897320"/>
              <a:ext cx="525240" cy="448920"/>
              <a:chOff x="3485880" y="7897320"/>
              <a:chExt cx="525240" cy="448920"/>
            </a:xfrm>
          </p:grpSpPr>
          <p:sp>
            <p:nvSpPr>
              <p:cNvPr id="315" name=""/>
              <p:cNvSpPr/>
              <p:nvPr/>
            </p:nvSpPr>
            <p:spPr>
              <a:xfrm flipV="1">
                <a:off x="3717000" y="7897320"/>
                <a:ext cx="0" cy="164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3485880" y="8008920"/>
                <a:ext cx="525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rAAV5-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egf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7" name=""/>
            <p:cNvSpPr/>
            <p:nvPr/>
          </p:nvSpPr>
          <p:spPr>
            <a:xfrm>
              <a:off x="4038480" y="784548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Week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1219320" y="6624720"/>
              <a:ext cx="407880" cy="318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1206360" y="6600960"/>
              <a:ext cx="395280" cy="1001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20" name=""/>
            <p:cNvGrpSpPr/>
            <p:nvPr/>
          </p:nvGrpSpPr>
          <p:grpSpPr>
            <a:xfrm>
              <a:off x="1287360" y="6272280"/>
              <a:ext cx="398520" cy="1288080"/>
              <a:chOff x="1287360" y="6272280"/>
              <a:chExt cx="398520" cy="1288080"/>
            </a:xfrm>
          </p:grpSpPr>
          <p:sp>
            <p:nvSpPr>
              <p:cNvPr id="321" name=""/>
              <p:cNvSpPr/>
              <p:nvPr/>
            </p:nvSpPr>
            <p:spPr>
              <a:xfrm>
                <a:off x="1458360" y="729792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1458360" y="695952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1458360" y="661032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1458360" y="627228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2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1657080" y="7370640"/>
                <a:ext cx="2880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1657080" y="7029360"/>
                <a:ext cx="2880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1657080" y="6678720"/>
                <a:ext cx="2880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1657080" y="6337440"/>
                <a:ext cx="2880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 rot="16200000">
                <a:off x="774000" y="6894360"/>
                <a:ext cx="1179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cell/ml of blood (x10</a:t>
                </a:r>
                <a:r>
                  <a:rPr b="1" lang="en-US" sz="1000" spc="-1" strike="noStrike" baseline="30000">
                    <a:solidFill>
                      <a:srgbClr val="000000"/>
                    </a:solidFill>
                    <a:latin typeface="Times New Roman"/>
                  </a:rPr>
                  <a:t>6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0" name=""/>
            <p:cNvSpPr/>
            <p:nvPr/>
          </p:nvSpPr>
          <p:spPr>
            <a:xfrm>
              <a:off x="1521000" y="614520"/>
              <a:ext cx="91800" cy="123840"/>
            </a:xfrm>
            <a:custGeom>
              <a:avLst/>
              <a:gdLst/>
              <a:ahLst/>
              <a:rect l="l" t="t" r="r" b="b"/>
              <a:pathLst>
                <a:path w="60" h="64">
                  <a:moveTo>
                    <a:pt x="30" y="0"/>
                  </a:moveTo>
                  <a:lnTo>
                    <a:pt x="60" y="32"/>
                  </a:lnTo>
                  <a:lnTo>
                    <a:pt x="30" y="64"/>
                  </a:lnTo>
                  <a:lnTo>
                    <a:pt x="0" y="32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ff0000"/>
            </a:solidFill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1531800" y="1833480"/>
              <a:ext cx="81000" cy="1112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32" name=""/>
            <p:cNvGrpSpPr/>
            <p:nvPr/>
          </p:nvGrpSpPr>
          <p:grpSpPr>
            <a:xfrm>
              <a:off x="4788000" y="781200"/>
              <a:ext cx="1341360" cy="599760"/>
              <a:chOff x="4788000" y="781200"/>
              <a:chExt cx="1341360" cy="599760"/>
            </a:xfrm>
          </p:grpSpPr>
          <p:sp>
            <p:nvSpPr>
              <p:cNvPr id="333" name=""/>
              <p:cNvSpPr/>
              <p:nvPr/>
            </p:nvSpPr>
            <p:spPr>
              <a:xfrm>
                <a:off x="4788000" y="781200"/>
                <a:ext cx="1341360" cy="59976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4852800" y="894960"/>
                <a:ext cx="266400" cy="0"/>
              </a:xfrm>
              <a:prstGeom prst="line">
                <a:avLst/>
              </a:prstGeom>
              <a:ln w="19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4948200" y="856800"/>
                <a:ext cx="75600" cy="7596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24" y="0"/>
                    </a:moveTo>
                    <a:lnTo>
                      <a:pt x="48" y="24"/>
                    </a:lnTo>
                    <a:lnTo>
                      <a:pt x="24" y="48"/>
                    </a:lnTo>
                    <a:lnTo>
                      <a:pt x="0" y="24"/>
                    </a:lnTo>
                    <a:lnTo>
                      <a:pt x="24" y="0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5147640" y="809280"/>
                <a:ext cx="878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NHP001 w/o I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4852800" y="1095120"/>
                <a:ext cx="266400" cy="0"/>
              </a:xfrm>
              <a:prstGeom prst="line">
                <a:avLst/>
              </a:prstGeom>
              <a:ln w="190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4948200" y="1056960"/>
                <a:ext cx="66240" cy="662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440" bIns="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5147640" y="1009440"/>
                <a:ext cx="921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NHP002 with I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4852800" y="1294920"/>
                <a:ext cx="266400" cy="0"/>
              </a:xfrm>
              <a:prstGeom prst="line">
                <a:avLst/>
              </a:prstGeom>
              <a:ln w="19080">
                <a:solidFill>
                  <a:srgbClr val="99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4948200" y="1257120"/>
                <a:ext cx="75600" cy="7560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24" y="0"/>
                    </a:moveTo>
                    <a:lnTo>
                      <a:pt x="48" y="48"/>
                    </a:lnTo>
                    <a:lnTo>
                      <a:pt x="0" y="48"/>
                    </a:lnTo>
                    <a:lnTo>
                      <a:pt x="24" y="0"/>
                    </a:lnTo>
                    <a:close/>
                  </a:path>
                </a:pathLst>
              </a:custGeom>
              <a:solidFill>
                <a:srgbClr val="993300"/>
              </a:solidFill>
              <a:ln w="9360">
                <a:solidFill>
                  <a:srgbClr val="9933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5147640" y="1209240"/>
                <a:ext cx="921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NHP003 with I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3" name=""/>
            <p:cNvGrpSpPr/>
            <p:nvPr/>
          </p:nvGrpSpPr>
          <p:grpSpPr>
            <a:xfrm>
              <a:off x="1579680" y="1884240"/>
              <a:ext cx="2268360" cy="169920"/>
              <a:chOff x="1579680" y="1884240"/>
              <a:chExt cx="2268360" cy="169920"/>
            </a:xfrm>
          </p:grpSpPr>
          <p:sp>
            <p:nvSpPr>
              <p:cNvPr id="344" name=""/>
              <p:cNvSpPr/>
              <p:nvPr/>
            </p:nvSpPr>
            <p:spPr>
              <a:xfrm>
                <a:off x="1579680" y="1884240"/>
                <a:ext cx="82440" cy="16992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1662120" y="2039760"/>
                <a:ext cx="155520" cy="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 flipV="1">
                <a:off x="1817640" y="2030400"/>
                <a:ext cx="401760" cy="936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2219400" y="2030400"/>
                <a:ext cx="393480" cy="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2619360" y="2030400"/>
                <a:ext cx="181080" cy="936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 flipV="1">
                <a:off x="2800440" y="1980720"/>
                <a:ext cx="231840" cy="5868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3032280" y="1981080"/>
                <a:ext cx="591840" cy="49320"/>
              </a:xfrm>
              <a:prstGeom prst="line">
                <a:avLst/>
              </a:prstGeom>
              <a:ln w="22320">
                <a:solidFill>
                  <a:srgbClr val="0000ff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3624120" y="2019240"/>
                <a:ext cx="77760" cy="1116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3701880" y="2030400"/>
                <a:ext cx="146160" cy="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53" name=""/>
            <p:cNvGrpSpPr/>
            <p:nvPr/>
          </p:nvGrpSpPr>
          <p:grpSpPr>
            <a:xfrm>
              <a:off x="1662120" y="6831000"/>
              <a:ext cx="2219400" cy="850680"/>
              <a:chOff x="1662120" y="6831000"/>
              <a:chExt cx="2219400" cy="850680"/>
            </a:xfrm>
          </p:grpSpPr>
          <p:sp>
            <p:nvSpPr>
              <p:cNvPr id="354" name=""/>
              <p:cNvSpPr/>
              <p:nvPr/>
            </p:nvSpPr>
            <p:spPr>
              <a:xfrm>
                <a:off x="1662120" y="6831000"/>
                <a:ext cx="84240" cy="65736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 flipV="1">
                <a:off x="1746360" y="7370280"/>
                <a:ext cx="150840" cy="11772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 flipV="1">
                <a:off x="1897200" y="7297200"/>
                <a:ext cx="385560" cy="7308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 flipV="1">
                <a:off x="2282760" y="7064280"/>
                <a:ext cx="374760" cy="23328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 flipV="1">
                <a:off x="2657520" y="6986520"/>
                <a:ext cx="208080" cy="7776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>
                <a:off x="2865600" y="6986520"/>
                <a:ext cx="206280" cy="11124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 flipV="1">
                <a:off x="3071880" y="6878160"/>
                <a:ext cx="585720" cy="219240"/>
              </a:xfrm>
              <a:prstGeom prst="line">
                <a:avLst/>
              </a:prstGeom>
              <a:ln w="22320">
                <a:solidFill>
                  <a:srgbClr val="0000ff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>
                <a:off x="3662280" y="6878520"/>
                <a:ext cx="68400" cy="75744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 flipV="1">
                <a:off x="3730680" y="7370280"/>
                <a:ext cx="150840" cy="311400"/>
              </a:xfrm>
              <a:prstGeom prst="line">
                <a:avLst/>
              </a:prstGeom>
              <a:ln w="2232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63" name=""/>
            <p:cNvGrpSpPr/>
            <p:nvPr/>
          </p:nvGrpSpPr>
          <p:grpSpPr>
            <a:xfrm>
              <a:off x="1662120" y="6646680"/>
              <a:ext cx="2219400" cy="982800"/>
              <a:chOff x="1662120" y="6646680"/>
              <a:chExt cx="2219400" cy="982800"/>
            </a:xfrm>
          </p:grpSpPr>
          <p:sp>
            <p:nvSpPr>
              <p:cNvPr id="364" name=""/>
              <p:cNvSpPr/>
              <p:nvPr/>
            </p:nvSpPr>
            <p:spPr>
              <a:xfrm>
                <a:off x="1662120" y="6711840"/>
                <a:ext cx="106200" cy="58572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 flipV="1">
                <a:off x="1768320" y="6959160"/>
                <a:ext cx="128880" cy="33804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 flipV="1">
                <a:off x="1897200" y="6921360"/>
                <a:ext cx="385560" cy="3816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 flipV="1">
                <a:off x="2282760" y="6878160"/>
                <a:ext cx="405000" cy="3204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 flipV="1">
                <a:off x="2687760" y="6646680"/>
                <a:ext cx="177840" cy="23148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>
                <a:off x="2865600" y="6647040"/>
                <a:ext cx="217440" cy="9828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3071880" y="6745320"/>
                <a:ext cx="584280" cy="0"/>
              </a:xfrm>
              <a:prstGeom prst="line">
                <a:avLst/>
              </a:prstGeom>
              <a:ln w="22320">
                <a:solidFill>
                  <a:srgbClr val="8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3662280" y="6745320"/>
                <a:ext cx="71640" cy="88416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 flipV="1">
                <a:off x="3740040" y="7064280"/>
                <a:ext cx="141480" cy="565200"/>
              </a:xfrm>
              <a:prstGeom prst="line">
                <a:avLst/>
              </a:prstGeom>
              <a:ln w="2232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73" name=""/>
            <p:cNvGrpSpPr/>
            <p:nvPr/>
          </p:nvGrpSpPr>
          <p:grpSpPr>
            <a:xfrm>
              <a:off x="1673280" y="6690960"/>
              <a:ext cx="2036880" cy="606600"/>
              <a:chOff x="1673280" y="6690960"/>
              <a:chExt cx="2036880" cy="606600"/>
            </a:xfrm>
          </p:grpSpPr>
          <p:sp>
            <p:nvSpPr>
              <p:cNvPr id="374" name=""/>
              <p:cNvSpPr/>
              <p:nvPr/>
            </p:nvSpPr>
            <p:spPr>
              <a:xfrm flipV="1">
                <a:off x="1673280" y="6878520"/>
                <a:ext cx="95040" cy="41904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 flipV="1">
                <a:off x="1746360" y="6865560"/>
                <a:ext cx="150840" cy="1260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1897200" y="6865920"/>
                <a:ext cx="385560" cy="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 flipV="1">
                <a:off x="2282760" y="6690960"/>
                <a:ext cx="405000" cy="17460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2687760" y="6691320"/>
                <a:ext cx="177840" cy="21924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2865600" y="6910560"/>
                <a:ext cx="206280" cy="13176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3083040" y="7042320"/>
                <a:ext cx="627120" cy="0"/>
              </a:xfrm>
              <a:prstGeom prst="line">
                <a:avLst/>
              </a:prstGeom>
              <a:ln w="22320">
                <a:solidFill>
                  <a:srgbClr val="ff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81" name=""/>
            <p:cNvGrpSpPr/>
            <p:nvPr/>
          </p:nvGrpSpPr>
          <p:grpSpPr>
            <a:xfrm>
              <a:off x="1657440" y="3782880"/>
              <a:ext cx="2092320" cy="684360"/>
              <a:chOff x="1657440" y="3782880"/>
              <a:chExt cx="2092320" cy="684360"/>
            </a:xfrm>
          </p:grpSpPr>
          <p:sp>
            <p:nvSpPr>
              <p:cNvPr id="382" name=""/>
              <p:cNvSpPr/>
              <p:nvPr/>
            </p:nvSpPr>
            <p:spPr>
              <a:xfrm flipV="1">
                <a:off x="1657440" y="4133880"/>
                <a:ext cx="88920" cy="33336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 flipV="1">
                <a:off x="1746360" y="4060440"/>
                <a:ext cx="150840" cy="7308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 flipV="1">
                <a:off x="1897200" y="3855600"/>
                <a:ext cx="385560" cy="20484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 flipV="1">
                <a:off x="2282760" y="3782880"/>
                <a:ext cx="405000" cy="7488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2687760" y="3782880"/>
                <a:ext cx="177840" cy="7488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2865600" y="3855960"/>
                <a:ext cx="220680" cy="68400"/>
              </a:xfrm>
              <a:prstGeom prst="line">
                <a:avLst/>
              </a:prstGeom>
              <a:ln w="223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3086280" y="3924360"/>
                <a:ext cx="663480" cy="0"/>
              </a:xfrm>
              <a:prstGeom prst="line">
                <a:avLst/>
              </a:prstGeom>
              <a:ln w="22320">
                <a:solidFill>
                  <a:srgbClr val="ff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89" name=""/>
            <p:cNvSpPr/>
            <p:nvPr/>
          </p:nvSpPr>
          <p:spPr>
            <a:xfrm>
              <a:off x="1563840" y="644400"/>
              <a:ext cx="93600" cy="517680"/>
            </a:xfrm>
            <a:prstGeom prst="line">
              <a:avLst/>
            </a:prstGeom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 flipV="1">
              <a:off x="1655640" y="1056960"/>
              <a:ext cx="158760" cy="104760"/>
            </a:xfrm>
            <a:prstGeom prst="line">
              <a:avLst/>
            </a:prstGeom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1814400" y="1057320"/>
              <a:ext cx="395280" cy="20520"/>
            </a:xfrm>
            <a:prstGeom prst="line">
              <a:avLst/>
            </a:prstGeom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 flipV="1">
              <a:off x="2209680" y="980640"/>
              <a:ext cx="403200" cy="96840"/>
            </a:xfrm>
            <a:prstGeom prst="line">
              <a:avLst/>
            </a:prstGeom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2612880" y="981000"/>
              <a:ext cx="184320" cy="71640"/>
            </a:xfrm>
            <a:prstGeom prst="line">
              <a:avLst/>
            </a:prstGeom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2805120" y="1052640"/>
              <a:ext cx="227160" cy="61920"/>
            </a:xfrm>
            <a:prstGeom prst="line">
              <a:avLst/>
            </a:prstGeom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3043080" y="1123920"/>
              <a:ext cx="667080" cy="0"/>
            </a:xfrm>
            <a:prstGeom prst="line">
              <a:avLst/>
            </a:prstGeom>
            <a:ln w="22320">
              <a:solidFill>
                <a:srgbClr val="ff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8T07:27:49Z</dcterms:created>
  <dc:creator>Centro de Tecnología Informática</dc:creator>
  <dc:description/>
  <dc:language>en-US</dc:language>
  <cp:lastModifiedBy>Centro de Tecnología Informática</cp:lastModifiedBy>
  <dcterms:modified xsi:type="dcterms:W3CDTF">2011-08-09T20:06:46Z</dcterms:modified>
  <cp:revision>52</cp:revision>
  <dc:subject/>
  <dc:title>Diapositiva 1</dc:title>
</cp:coreProperties>
</file>